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C28A129-F7EA-42DD-8B23-19C62B8D17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03FBD14-8DA7-4D81-BD7B-17EAB1662E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C7A4A23-8A7C-46C1-B739-10BEAA857B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F559B-0FDC-4677-9596-B4FBF776206C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94E539-F8BA-4DBD-8584-F7C808B167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3C5788B-2B40-4628-B606-8424543345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4B8AC-5A45-4956-9744-42B45D443C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1783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2EB5426-5B80-4E25-91A0-A354F4D991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FD2F1A8-2874-4BDB-A977-40B409EA5F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34C2DCA-5A96-4ABF-B03E-199435DBD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F559B-0FDC-4677-9596-B4FBF776206C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5D5A9E9-87D4-45ED-A5F4-887A143114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65C00A9-2AB8-41F3-913C-FED692AFF4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4B8AC-5A45-4956-9744-42B45D443C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46048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74B2411-D47D-431C-8090-DF1C28185C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78FDDCF-C0C9-405B-AFB1-96FAF91FE8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DC3706E-BA8F-4A99-864A-17C6C757CC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F559B-0FDC-4677-9596-B4FBF776206C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8EA6928-7D7F-4A81-BDF1-28E5845C4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135F969-68EE-4974-9E42-50F59540DF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4B8AC-5A45-4956-9744-42B45D443C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2666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E38849-90CE-4D7D-BB4C-E3CA4A9BF9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F632578-E159-4229-8BBC-36A92D6668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7EA4EE-B404-4F47-80D1-BAEA1E8F15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F559B-0FDC-4677-9596-B4FBF776206C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D97C4B7-2B43-40EB-BF20-2D78575EC5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69689A9-24B2-4609-891B-314646DA29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4B8AC-5A45-4956-9744-42B45D443C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55088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F25B291-FF2E-4924-883F-A3EEEEB5EA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092F0F0-1099-4400-90F7-14AFDCA408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0630E12-EC12-49B8-8526-D9ADD1A54E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F559B-0FDC-4677-9596-B4FBF776206C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9CCBFB2-47E4-45B1-81D5-FD046BF0C1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980CC60-220B-435E-A269-D7D32FD77D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4B8AC-5A45-4956-9744-42B45D443C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69095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2F65836-37EF-47FE-A39A-A03B7C455E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CB64AED-B47D-4725-957F-ADDCC4F1A8A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17E79A5-CD97-4B66-8BA3-79EDC370467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C48C993-1614-4AD2-9BCA-264B70C63E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F559B-0FDC-4677-9596-B4FBF776206C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45AE7D9-D89D-4574-863A-E11EB32A54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6D0C090-2EFF-4560-B5C1-0B0BB02BE6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4B8AC-5A45-4956-9744-42B45D443C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0365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92CC859-B4FB-4D73-9C45-172C72721D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0AA0E60-510D-4F6D-B434-DFF23E298B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D444A9F-343F-48E7-9B72-DF5FF258E9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B454C3C-CFA5-4E97-8DD8-7FBC0EC0D4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0BFA315-EB8F-410F-A79C-A4CA0A5F2F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3245299-B0E3-4013-B1FA-884F01C310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F559B-0FDC-4677-9596-B4FBF776206C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D094523-6733-4EC4-B250-E1A975F868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44B25FF-8259-4048-9534-742986ABE4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4B8AC-5A45-4956-9744-42B45D443C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51816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9C0FC4-4F5A-4935-A702-F8E9FE137B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684707E-124F-4A6B-B442-3DC0100900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F559B-0FDC-4677-9596-B4FBF776206C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E33F0BE-8DAD-4164-962A-59EDE41039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7100018-C0BC-4FAD-98A1-525821EE93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4B8AC-5A45-4956-9744-42B45D443C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2283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634A46E-0EF7-49D3-B236-D25216BAF9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F559B-0FDC-4677-9596-B4FBF776206C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CA0465A-C064-4D38-8830-6F686753B0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8C80065-82E3-466B-98CB-C057250BCB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4B8AC-5A45-4956-9744-42B45D443C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07993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B128B0-5346-4825-904F-618F425FFA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1592264-0821-47D2-BEF2-EC2D5882C6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1F3D042-031B-49ED-B708-64A51CB3F6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B398E4D-ED3E-4249-A9D6-344803E784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F559B-0FDC-4677-9596-B4FBF776206C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09BE649-2E43-4F50-AA7C-6DDD630ADE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716D9F5-D81E-45E5-B493-2738FD3012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4B8AC-5A45-4956-9744-42B45D443C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67494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828AD45-D660-46FF-A9C0-B4A0590560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5F27B08-4F1E-4DCD-A9BC-9CE5264819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85D413D-BF3A-4236-99E4-C27BDC66B7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C326151-B89D-4C32-ACA7-72D179D46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F559B-0FDC-4677-9596-B4FBF776206C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B19B1C8-D15E-48CF-9AC7-9113D3E6E1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C73DFFF-3C80-4184-931A-A2C89C2D8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B4B8AC-5A45-4956-9744-42B45D443C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42557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9F3AE98-8527-471E-B2FA-6C8730125E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9A001BE-50BB-4FBB-B0E2-F4E0EA3647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C76A1F2-6BF9-4CE8-B608-A4C1584B003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7F559B-0FDC-4677-9596-B4FBF776206C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4B78C1-F4AE-490E-A72F-08527FD5215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8937946-C0B4-424A-B580-647C1A1349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B4B8AC-5A45-4956-9744-42B45D443C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3536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8.png"/><Relationship Id="rId4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12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AFCFAEF2-9CC6-4E0D-A96E-70F55DEE6C80}"/>
              </a:ext>
            </a:extLst>
          </p:cNvPr>
          <p:cNvSpPr txBox="1"/>
          <p:nvPr/>
        </p:nvSpPr>
        <p:spPr>
          <a:xfrm>
            <a:off x="100361" y="5657671"/>
            <a:ext cx="1164265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A. MS/MS spectrum of a precursor at m/z 746.5259 (ID: 0.97_746.5259m/z, RT=0.97 min) in positive mode with adducts [M+H-H2O]</a:t>
            </a:r>
            <a:r>
              <a:rPr lang="en-US" altLang="zh-CN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MS/MS spectrum was generated from MS</a:t>
            </a:r>
            <a:r>
              <a:rPr lang="en-US" altLang="zh-CN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w data using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genesi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QI software. Fragments indicate that it’s PS(34:0). The lightning shape represents the site of  bond breakage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grpSp>
        <p:nvGrpSpPr>
          <p:cNvPr id="66" name="组合 65">
            <a:extLst>
              <a:ext uri="{FF2B5EF4-FFF2-40B4-BE49-F238E27FC236}">
                <a16:creationId xmlns:a16="http://schemas.microsoft.com/office/drawing/2014/main" id="{0A03C51C-022D-412E-948C-BD1C8ABF8F80}"/>
              </a:ext>
            </a:extLst>
          </p:cNvPr>
          <p:cNvGrpSpPr/>
          <p:nvPr/>
        </p:nvGrpSpPr>
        <p:grpSpPr>
          <a:xfrm>
            <a:off x="144965" y="330273"/>
            <a:ext cx="11601536" cy="4904525"/>
            <a:chOff x="111511" y="352576"/>
            <a:chExt cx="11601536" cy="4904525"/>
          </a:xfrm>
        </p:grpSpPr>
        <p:grpSp>
          <p:nvGrpSpPr>
            <p:cNvPr id="59" name="组合 58">
              <a:extLst>
                <a:ext uri="{FF2B5EF4-FFF2-40B4-BE49-F238E27FC236}">
                  <a16:creationId xmlns:a16="http://schemas.microsoft.com/office/drawing/2014/main" id="{A18D2C08-F6FA-4AC2-8466-DF6AD192AD01}"/>
                </a:ext>
              </a:extLst>
            </p:cNvPr>
            <p:cNvGrpSpPr/>
            <p:nvPr/>
          </p:nvGrpSpPr>
          <p:grpSpPr>
            <a:xfrm>
              <a:off x="5552146" y="4448578"/>
              <a:ext cx="3714518" cy="808523"/>
              <a:chOff x="7960809" y="5586003"/>
              <a:chExt cx="3714518" cy="808523"/>
            </a:xfrm>
          </p:grpSpPr>
          <p:pic>
            <p:nvPicPr>
              <p:cNvPr id="43" name="图片 42">
                <a:extLst>
                  <a:ext uri="{FF2B5EF4-FFF2-40B4-BE49-F238E27FC236}">
                    <a16:creationId xmlns:a16="http://schemas.microsoft.com/office/drawing/2014/main" id="{E900F6B6-2325-4654-AC15-9DEAFB8D877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7960809" y="5586003"/>
                <a:ext cx="3714518" cy="808523"/>
              </a:xfrm>
              <a:prstGeom prst="rect">
                <a:avLst/>
              </a:prstGeom>
            </p:spPr>
          </p:pic>
          <p:sp>
            <p:nvSpPr>
              <p:cNvPr id="56" name="闪电形 55">
                <a:extLst>
                  <a:ext uri="{FF2B5EF4-FFF2-40B4-BE49-F238E27FC236}">
                    <a16:creationId xmlns:a16="http://schemas.microsoft.com/office/drawing/2014/main" id="{8A3D1A59-09DD-4113-A4AF-EECDB87C7C5B}"/>
                  </a:ext>
                </a:extLst>
              </p:cNvPr>
              <p:cNvSpPr/>
              <p:nvPr/>
            </p:nvSpPr>
            <p:spPr>
              <a:xfrm rot="2242138">
                <a:off x="10627112" y="5820937"/>
                <a:ext cx="111512" cy="245326"/>
              </a:xfrm>
              <a:prstGeom prst="lightningBol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64" name="组合 63">
              <a:extLst>
                <a:ext uri="{FF2B5EF4-FFF2-40B4-BE49-F238E27FC236}">
                  <a16:creationId xmlns:a16="http://schemas.microsoft.com/office/drawing/2014/main" id="{F413A47E-7B1C-4348-B617-E22DFE4112F1}"/>
                </a:ext>
              </a:extLst>
            </p:cNvPr>
            <p:cNvGrpSpPr/>
            <p:nvPr/>
          </p:nvGrpSpPr>
          <p:grpSpPr>
            <a:xfrm>
              <a:off x="146739" y="352576"/>
              <a:ext cx="11566308" cy="3977882"/>
              <a:chOff x="191344" y="1333883"/>
              <a:chExt cx="11566308" cy="3977882"/>
            </a:xfrm>
          </p:grpSpPr>
          <p:grpSp>
            <p:nvGrpSpPr>
              <p:cNvPr id="42" name="组合 41">
                <a:extLst>
                  <a:ext uri="{FF2B5EF4-FFF2-40B4-BE49-F238E27FC236}">
                    <a16:creationId xmlns:a16="http://schemas.microsoft.com/office/drawing/2014/main" id="{8B9EA917-DBEA-4A9A-9784-7D8325F767CB}"/>
                  </a:ext>
                </a:extLst>
              </p:cNvPr>
              <p:cNvGrpSpPr/>
              <p:nvPr/>
            </p:nvGrpSpPr>
            <p:grpSpPr>
              <a:xfrm>
                <a:off x="191344" y="1333883"/>
                <a:ext cx="11566308" cy="3977882"/>
                <a:chOff x="191344" y="2043406"/>
                <a:chExt cx="11566308" cy="3977882"/>
              </a:xfrm>
            </p:grpSpPr>
            <p:grpSp>
              <p:nvGrpSpPr>
                <p:cNvPr id="40" name="组合 39">
                  <a:extLst>
                    <a:ext uri="{FF2B5EF4-FFF2-40B4-BE49-F238E27FC236}">
                      <a16:creationId xmlns:a16="http://schemas.microsoft.com/office/drawing/2014/main" id="{D0F9D6FD-D9E0-473A-83F1-03F0D2B7CB57}"/>
                    </a:ext>
                  </a:extLst>
                </p:cNvPr>
                <p:cNvGrpSpPr/>
                <p:nvPr/>
              </p:nvGrpSpPr>
              <p:grpSpPr>
                <a:xfrm>
                  <a:off x="191344" y="2738526"/>
                  <a:ext cx="11566308" cy="3282762"/>
                  <a:chOff x="194510" y="2152465"/>
                  <a:chExt cx="11566308" cy="3282762"/>
                </a:xfrm>
              </p:grpSpPr>
              <p:pic>
                <p:nvPicPr>
                  <p:cNvPr id="7" name="图片 6">
                    <a:extLst>
                      <a:ext uri="{FF2B5EF4-FFF2-40B4-BE49-F238E27FC236}">
                        <a16:creationId xmlns:a16="http://schemas.microsoft.com/office/drawing/2014/main" id="{24008260-9DF8-453C-82AC-D9DF3C6387F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94510" y="2553629"/>
                    <a:ext cx="11354789" cy="2881598"/>
                  </a:xfrm>
                  <a:prstGeom prst="rect">
                    <a:avLst/>
                  </a:prstGeom>
                </p:spPr>
              </p:pic>
              <p:pic>
                <p:nvPicPr>
                  <p:cNvPr id="14" name="图片 13">
                    <a:extLst>
                      <a:ext uri="{FF2B5EF4-FFF2-40B4-BE49-F238E27FC236}">
                        <a16:creationId xmlns:a16="http://schemas.microsoft.com/office/drawing/2014/main" id="{BA6459CB-9101-443A-B049-3B888988BFE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576" t="14634" r="7333" b="71471"/>
                  <a:stretch/>
                </p:blipFill>
                <p:spPr>
                  <a:xfrm>
                    <a:off x="979076" y="2152465"/>
                    <a:ext cx="1337310" cy="251460"/>
                  </a:xfrm>
                  <a:prstGeom prst="rect">
                    <a:avLst/>
                  </a:prstGeom>
                </p:spPr>
              </p:pic>
              <p:sp>
                <p:nvSpPr>
                  <p:cNvPr id="15" name="文本框 14">
                    <a:extLst>
                      <a:ext uri="{FF2B5EF4-FFF2-40B4-BE49-F238E27FC236}">
                        <a16:creationId xmlns:a16="http://schemas.microsoft.com/office/drawing/2014/main" id="{478D9C96-62D6-475D-A819-BD36A5FD5090}"/>
                      </a:ext>
                    </a:extLst>
                  </p:cNvPr>
                  <p:cNvSpPr txBox="1"/>
                  <p:nvPr/>
                </p:nvSpPr>
                <p:spPr>
                  <a:xfrm>
                    <a:off x="646817" y="2798834"/>
                    <a:ext cx="1672636" cy="861774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r>
                      <a:rPr lang="en-US" altLang="zh-CN" sz="1000" b="1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4</a:t>
                    </a:r>
                    <a:r>
                      <a:rPr lang="en-US" altLang="zh-CN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</a:t>
                    </a:r>
                    <a:r>
                      <a:rPr lang="en-US" altLang="zh-CN" sz="1000" b="1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7</a:t>
                    </a:r>
                    <a:r>
                      <a:rPr lang="en-US" altLang="zh-CN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</a:t>
                    </a:r>
                    <a:r>
                      <a:rPr lang="en-US" altLang="zh-CN" sz="1000" b="1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altLang="zh-CN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e</a:t>
                    </a:r>
                  </a:p>
                  <a:p>
                    <a:r>
                      <a:rPr lang="en-US" altLang="zh-CN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ragment m/z:</a:t>
                    </a:r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227.2006</a:t>
                    </a:r>
                  </a:p>
                  <a:p>
                    <a:r>
                      <a:rPr lang="en-US" altLang="zh-CN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eak m/z:</a:t>
                    </a:r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227.2014</a:t>
                    </a:r>
                  </a:p>
                  <a:p>
                    <a:r>
                      <a:rPr lang="en-US" altLang="zh-CN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rror (ppm): </a:t>
                    </a:r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.58</a:t>
                    </a:r>
                  </a:p>
                  <a:p>
                    <a:r>
                      <a:rPr lang="en-US" altLang="zh-CN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arge: </a:t>
                    </a:r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  <a:endParaRPr lang="zh-CN" altLang="en-US" sz="105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17" name="图片 16">
                    <a:extLst>
                      <a:ext uri="{FF2B5EF4-FFF2-40B4-BE49-F238E27FC236}">
                        <a16:creationId xmlns:a16="http://schemas.microsoft.com/office/drawing/2014/main" id="{AA9EFF88-59DF-4525-8D4A-A0A9B9A99F6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178" t="11212" r="6203" b="70606"/>
                  <a:stretch/>
                </p:blipFill>
                <p:spPr>
                  <a:xfrm>
                    <a:off x="6103621" y="4404732"/>
                    <a:ext cx="1593264" cy="405067"/>
                  </a:xfrm>
                  <a:prstGeom prst="rect">
                    <a:avLst/>
                  </a:prstGeom>
                </p:spPr>
              </p:pic>
              <p:cxnSp>
                <p:nvCxnSpPr>
                  <p:cNvPr id="19" name="直接箭头连接符 18">
                    <a:extLst>
                      <a:ext uri="{FF2B5EF4-FFF2-40B4-BE49-F238E27FC236}">
                        <a16:creationId xmlns:a16="http://schemas.microsoft.com/office/drawing/2014/main" id="{54A22C64-B6F6-4274-BEA6-DE3C8692C3B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2207941" y="2419813"/>
                    <a:ext cx="240030" cy="211316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" name="直接箭头连接符 22">
                    <a:extLst>
                      <a:ext uri="{FF2B5EF4-FFF2-40B4-BE49-F238E27FC236}">
                        <a16:creationId xmlns:a16="http://schemas.microsoft.com/office/drawing/2014/main" id="{B086933D-348D-466A-864D-677E2ECA595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7270595" y="4673755"/>
                    <a:ext cx="223024" cy="199328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4" name="文本框 23">
                    <a:extLst>
                      <a:ext uri="{FF2B5EF4-FFF2-40B4-BE49-F238E27FC236}">
                        <a16:creationId xmlns:a16="http://schemas.microsoft.com/office/drawing/2014/main" id="{7B08E53E-94C7-4D76-A394-1C55BEEADC82}"/>
                      </a:ext>
                    </a:extLst>
                  </p:cNvPr>
                  <p:cNvSpPr txBox="1"/>
                  <p:nvPr/>
                </p:nvSpPr>
                <p:spPr>
                  <a:xfrm>
                    <a:off x="5611852" y="3186739"/>
                    <a:ext cx="1413417" cy="1169551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lvl="0"/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r>
                      <a:rPr lang="en-US" altLang="zh-CN" sz="1000" b="1" baseline="-250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7</a:t>
                    </a:r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</a:t>
                    </a:r>
                    <a:r>
                      <a:rPr lang="en-US" altLang="zh-CN" sz="1000" b="1" baseline="-250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</a:t>
                    </a:r>
                    <a:r>
                      <a:rPr lang="en-US" altLang="zh-CN" sz="1000" b="1" baseline="-250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9</a:t>
                    </a:r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-e</a:t>
                    </a:r>
                  </a:p>
                  <a:p>
                    <a:pPr lvl="0"/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ragment m/z:</a:t>
                    </a:r>
                    <a:r>
                      <a:rPr lang="en-US" altLang="zh-CN" sz="10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550.3266</a:t>
                    </a:r>
                  </a:p>
                  <a:p>
                    <a:pPr lvl="0"/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eak m/z:</a:t>
                    </a:r>
                    <a:r>
                      <a:rPr lang="en-US" altLang="zh-CN" sz="10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550.3310</a:t>
                    </a:r>
                  </a:p>
                  <a:p>
                    <a:pPr lvl="0"/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rror (ppm): </a:t>
                    </a:r>
                    <a:r>
                      <a:rPr lang="en-US" altLang="zh-CN" sz="10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.03</a:t>
                    </a:r>
                  </a:p>
                  <a:p>
                    <a:pPr lvl="0"/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arge: </a:t>
                    </a:r>
                    <a:r>
                      <a:rPr lang="en-US" altLang="zh-CN" sz="10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  <a:p>
                    <a:pPr lvl="0"/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eutral change:</a:t>
                    </a:r>
                    <a:r>
                      <a:rPr lang="en-US" altLang="zh-CN" sz="10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H</a:t>
                    </a:r>
                    <a:endParaRPr lang="zh-CN" altLang="en-US" dirty="0"/>
                  </a:p>
                </p:txBody>
              </p:sp>
              <p:cxnSp>
                <p:nvCxnSpPr>
                  <p:cNvPr id="27" name="直接箭头连接符 26">
                    <a:extLst>
                      <a:ext uri="{FF2B5EF4-FFF2-40B4-BE49-F238E27FC236}">
                        <a16:creationId xmlns:a16="http://schemas.microsoft.com/office/drawing/2014/main" id="{B0DCC50D-3E4D-40B4-9AE3-15224D3C5B46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8207297" y="4661210"/>
                    <a:ext cx="245327" cy="17842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pic>
                <p:nvPicPr>
                  <p:cNvPr id="29" name="图片 28">
                    <a:extLst>
                      <a:ext uri="{FF2B5EF4-FFF2-40B4-BE49-F238E27FC236}">
                        <a16:creationId xmlns:a16="http://schemas.microsoft.com/office/drawing/2014/main" id="{77E1DCB9-8A0E-4F19-A6C6-03A377090F8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6724" t="12088" r="3220" b="75174"/>
                  <a:stretch/>
                </p:blipFill>
                <p:spPr>
                  <a:xfrm>
                    <a:off x="8017727" y="4404732"/>
                    <a:ext cx="1338146" cy="234176"/>
                  </a:xfrm>
                  <a:prstGeom prst="rect">
                    <a:avLst/>
                  </a:prstGeom>
                </p:spPr>
              </p:pic>
              <p:sp>
                <p:nvSpPr>
                  <p:cNvPr id="30" name="文本框 29">
                    <a:extLst>
                      <a:ext uri="{FF2B5EF4-FFF2-40B4-BE49-F238E27FC236}">
                        <a16:creationId xmlns:a16="http://schemas.microsoft.com/office/drawing/2014/main" id="{7987BC38-6F51-4C6D-A028-200C9ACD2063}"/>
                      </a:ext>
                    </a:extLst>
                  </p:cNvPr>
                  <p:cNvSpPr txBox="1"/>
                  <p:nvPr/>
                </p:nvSpPr>
                <p:spPr>
                  <a:xfrm>
                    <a:off x="7983345" y="3183022"/>
                    <a:ext cx="1413417" cy="1169551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lvl="0"/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r>
                      <a:rPr lang="en-US" altLang="zh-CN" sz="1000" b="1" baseline="-250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9</a:t>
                    </a:r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</a:t>
                    </a:r>
                    <a:r>
                      <a:rPr lang="en-US" altLang="zh-CN" sz="1000" b="1" baseline="-250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2</a:t>
                    </a:r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</a:t>
                    </a:r>
                    <a:r>
                      <a:rPr lang="en-US" altLang="zh-CN" sz="1000" b="1" baseline="-250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-e</a:t>
                    </a:r>
                  </a:p>
                  <a:p>
                    <a:pPr lvl="0"/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ragment m/z:</a:t>
                    </a:r>
                    <a:r>
                      <a:rPr lang="en-US" altLang="zh-CN" sz="10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590.3215</a:t>
                    </a:r>
                  </a:p>
                  <a:p>
                    <a:pPr lvl="0"/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eak m/z:</a:t>
                    </a:r>
                    <a:r>
                      <a:rPr lang="en-US" altLang="zh-CN" sz="10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590.3223</a:t>
                    </a:r>
                  </a:p>
                  <a:p>
                    <a:pPr lvl="0"/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rror (ppm): </a:t>
                    </a:r>
                    <a:r>
                      <a:rPr lang="en-US" altLang="zh-CN" sz="10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51</a:t>
                    </a:r>
                  </a:p>
                  <a:p>
                    <a:pPr lvl="0"/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arge: </a:t>
                    </a:r>
                    <a:r>
                      <a:rPr lang="en-US" altLang="zh-CN" sz="10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</a:p>
                  <a:p>
                    <a:pPr lvl="0"/>
                    <a:r>
                      <a:rPr lang="en-US" altLang="zh-CN" sz="1000" b="1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eutral change:-</a:t>
                    </a:r>
                    <a:r>
                      <a:rPr lang="en-US" altLang="zh-CN" sz="1000" dirty="0">
                        <a:solidFill>
                          <a:prstClr val="black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</a:t>
                    </a:r>
                    <a:endParaRPr lang="zh-CN" altLang="en-US" dirty="0"/>
                  </a:p>
                </p:txBody>
              </p:sp>
              <p:cxnSp>
                <p:nvCxnSpPr>
                  <p:cNvPr id="32" name="直接箭头连接符 31">
                    <a:extLst>
                      <a:ext uri="{FF2B5EF4-FFF2-40B4-BE49-F238E27FC236}">
                        <a16:creationId xmlns:a16="http://schemas.microsoft.com/office/drawing/2014/main" id="{33E26ADE-CEE3-4700-B87A-7DE7CB25B2C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10370634" y="4661211"/>
                    <a:ext cx="234176" cy="189569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pic>
                <p:nvPicPr>
                  <p:cNvPr id="35" name="图片 34">
                    <a:extLst>
                      <a:ext uri="{FF2B5EF4-FFF2-40B4-BE49-F238E27FC236}">
                        <a16:creationId xmlns:a16="http://schemas.microsoft.com/office/drawing/2014/main" id="{003A06AA-FF13-44C4-A0C4-CF1AF63F8C1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199" t="12181" r="9716" b="72691"/>
                  <a:stretch/>
                </p:blipFill>
                <p:spPr>
                  <a:xfrm>
                    <a:off x="10158760" y="4415883"/>
                    <a:ext cx="1333302" cy="278781"/>
                  </a:xfrm>
                  <a:prstGeom prst="rect">
                    <a:avLst/>
                  </a:prstGeom>
                </p:spPr>
              </p:pic>
              <p:sp>
                <p:nvSpPr>
                  <p:cNvPr id="37" name="文本框 36">
                    <a:extLst>
                      <a:ext uri="{FF2B5EF4-FFF2-40B4-BE49-F238E27FC236}">
                        <a16:creationId xmlns:a16="http://schemas.microsoft.com/office/drawing/2014/main" id="{7ACB7456-FC81-43E6-8824-C08840C09867}"/>
                      </a:ext>
                    </a:extLst>
                  </p:cNvPr>
                  <p:cNvSpPr txBox="1"/>
                  <p:nvPr/>
                </p:nvSpPr>
                <p:spPr>
                  <a:xfrm>
                    <a:off x="10088182" y="3486492"/>
                    <a:ext cx="1672636" cy="861774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  <a:r>
                      <a:rPr lang="en-US" altLang="zh-CN" sz="1000" b="1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</a:t>
                    </a:r>
                    <a:r>
                      <a:rPr lang="en-US" altLang="zh-CN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</a:t>
                    </a:r>
                    <a:r>
                      <a:rPr lang="en-US" altLang="zh-CN" sz="1000" b="1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5</a:t>
                    </a:r>
                    <a:r>
                      <a:rPr lang="en-US" altLang="zh-CN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</a:t>
                    </a:r>
                    <a:r>
                      <a:rPr lang="en-US" altLang="zh-CN" sz="1000" b="1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</a:t>
                    </a:r>
                    <a:r>
                      <a:rPr lang="en-US" altLang="zh-CN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+H-H</a:t>
                    </a:r>
                    <a:r>
                      <a:rPr lang="en-US" altLang="zh-CN" sz="1000" b="1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</a:t>
                    </a:r>
                    <a:r>
                      <a:rPr lang="en-US" altLang="zh-CN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</a:t>
                    </a:r>
                  </a:p>
                  <a:p>
                    <a:r>
                      <a:rPr lang="en-US" altLang="zh-CN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ragment m/z:</a:t>
                    </a:r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729.5065</a:t>
                    </a:r>
                  </a:p>
                  <a:p>
                    <a:r>
                      <a:rPr lang="en-US" altLang="zh-CN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eak m/z:</a:t>
                    </a:r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729.5013</a:t>
                    </a:r>
                  </a:p>
                  <a:p>
                    <a:r>
                      <a:rPr lang="en-US" altLang="zh-CN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rror (ppm): </a:t>
                    </a:r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7.21</a:t>
                    </a:r>
                  </a:p>
                  <a:p>
                    <a:r>
                      <a:rPr lang="en-US" altLang="zh-CN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harge: </a:t>
                    </a:r>
                    <a:r>
                      <a:rPr lang="en-US" altLang="zh-CN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</a:t>
                    </a:r>
                    <a:endParaRPr lang="zh-CN" altLang="en-US" sz="105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pic>
              <p:nvPicPr>
                <p:cNvPr id="39" name="图片 38">
                  <a:extLst>
                    <a:ext uri="{FF2B5EF4-FFF2-40B4-BE49-F238E27FC236}">
                      <a16:creationId xmlns:a16="http://schemas.microsoft.com/office/drawing/2014/main" id="{283FEC3B-8212-45CE-9758-677C7554785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-612" b="66992"/>
                <a:stretch/>
              </p:blipFill>
              <p:spPr>
                <a:xfrm>
                  <a:off x="6717852" y="2043406"/>
                  <a:ext cx="4953309" cy="1163989"/>
                </a:xfrm>
                <a:prstGeom prst="rect">
                  <a:avLst/>
                </a:prstGeom>
              </p:spPr>
            </p:pic>
            <p:sp>
              <p:nvSpPr>
                <p:cNvPr id="41" name="文本框 40">
                  <a:extLst>
                    <a:ext uri="{FF2B5EF4-FFF2-40B4-BE49-F238E27FC236}">
                      <a16:creationId xmlns:a16="http://schemas.microsoft.com/office/drawing/2014/main" id="{5054F1FC-CAAF-4587-B31C-2791077EEF19}"/>
                    </a:ext>
                  </a:extLst>
                </p:cNvPr>
                <p:cNvSpPr txBox="1"/>
                <p:nvPr/>
              </p:nvSpPr>
              <p:spPr>
                <a:xfrm>
                  <a:off x="5265785" y="2403829"/>
                  <a:ext cx="3512635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S(34:0)</a:t>
                  </a:r>
                  <a:endParaRPr lang="zh-CN" altLang="en-US" b="1" dirty="0"/>
                </a:p>
              </p:txBody>
            </p:sp>
          </p:grpSp>
          <p:pic>
            <p:nvPicPr>
              <p:cNvPr id="57" name="图片 56">
                <a:extLst>
                  <a:ext uri="{FF2B5EF4-FFF2-40B4-BE49-F238E27FC236}">
                    <a16:creationId xmlns:a16="http://schemas.microsoft.com/office/drawing/2014/main" id="{9F0BA386-19CB-473F-A08E-96A07E66A67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 rot="757586">
                <a:off x="9996766" y="1613049"/>
                <a:ext cx="115834" cy="286537"/>
              </a:xfrm>
              <a:prstGeom prst="rect">
                <a:avLst/>
              </a:prstGeom>
            </p:spPr>
          </p:pic>
          <p:sp>
            <p:nvSpPr>
              <p:cNvPr id="58" name="闪电形 57">
                <a:extLst>
                  <a:ext uri="{FF2B5EF4-FFF2-40B4-BE49-F238E27FC236}">
                    <a16:creationId xmlns:a16="http://schemas.microsoft.com/office/drawing/2014/main" id="{D20595D2-7B9F-4C78-9867-40517B893115}"/>
                  </a:ext>
                </a:extLst>
              </p:cNvPr>
              <p:cNvSpPr/>
              <p:nvPr/>
            </p:nvSpPr>
            <p:spPr>
              <a:xfrm rot="2242138">
                <a:off x="9722835" y="1627081"/>
                <a:ext cx="80299" cy="206887"/>
              </a:xfrm>
              <a:prstGeom prst="lightningBol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39FDDBB1-C121-4500-B1D2-460F00BB182D}"/>
                </a:ext>
              </a:extLst>
            </p:cNvPr>
            <p:cNvSpPr txBox="1"/>
            <p:nvPr/>
          </p:nvSpPr>
          <p:spPr>
            <a:xfrm>
              <a:off x="111511" y="4627756"/>
              <a:ext cx="50626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Corresponding IS: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15:0-18:1(d7) PS (Na Salt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5" name="文本框 64">
            <a:extLst>
              <a:ext uri="{FF2B5EF4-FFF2-40B4-BE49-F238E27FC236}">
                <a16:creationId xmlns:a16="http://schemas.microsoft.com/office/drawing/2014/main" id="{8166CD7F-ABAB-4E54-ABE4-05828D071AA2}"/>
              </a:ext>
            </a:extLst>
          </p:cNvPr>
          <p:cNvSpPr txBox="1"/>
          <p:nvPr/>
        </p:nvSpPr>
        <p:spPr>
          <a:xfrm>
            <a:off x="122663" y="267630"/>
            <a:ext cx="7136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7" name="图片 66">
            <a:extLst>
              <a:ext uri="{FF2B5EF4-FFF2-40B4-BE49-F238E27FC236}">
                <a16:creationId xmlns:a16="http://schemas.microsoft.com/office/drawing/2014/main" id="{63602BA0-AE12-43A1-A40B-2509706AD5F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rot="12703906">
            <a:off x="10974357" y="683780"/>
            <a:ext cx="115834" cy="286537"/>
          </a:xfrm>
          <a:prstGeom prst="rect">
            <a:avLst/>
          </a:prstGeom>
        </p:spPr>
      </p:pic>
      <p:pic>
        <p:nvPicPr>
          <p:cNvPr id="68" name="图片 67">
            <a:extLst>
              <a:ext uri="{FF2B5EF4-FFF2-40B4-BE49-F238E27FC236}">
                <a16:creationId xmlns:a16="http://schemas.microsoft.com/office/drawing/2014/main" id="{9F14EBB0-265B-4907-921B-F2B562B0226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rot="18917312">
            <a:off x="9561715" y="620767"/>
            <a:ext cx="107306" cy="2654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55273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705DCE1-EB59-4D44-A09B-66FD8AFEBB80}"/>
              </a:ext>
            </a:extLst>
          </p:cNvPr>
          <p:cNvSpPr txBox="1"/>
          <p:nvPr/>
        </p:nvSpPr>
        <p:spPr>
          <a:xfrm>
            <a:off x="99389" y="5657671"/>
            <a:ext cx="1164265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B. MS/MS spectrum of a precursor at m/z 426.3049 (ID: 0.95_426.3049m/z, RT=0.95 min) in positive mode with adducts [M+2H]</a:t>
            </a:r>
            <a:r>
              <a:rPr lang="en-US" altLang="zh-CN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+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MS/MS spectrum was generated from MS</a:t>
            </a:r>
            <a:r>
              <a:rPr lang="en-US" altLang="zh-CN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w data using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genesi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QI software. Fragments indicate that it’s PI (O-36:1). The lightning shape represents the site of  bond breakage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686F452C-FB6A-431D-A5F1-28770B44F84D}"/>
              </a:ext>
            </a:extLst>
          </p:cNvPr>
          <p:cNvSpPr txBox="1"/>
          <p:nvPr/>
        </p:nvSpPr>
        <p:spPr>
          <a:xfrm>
            <a:off x="122663" y="267630"/>
            <a:ext cx="7136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13D38657-16F0-42FA-8DB5-78D0BB07EEC0}"/>
              </a:ext>
            </a:extLst>
          </p:cNvPr>
          <p:cNvGrpSpPr/>
          <p:nvPr/>
        </p:nvGrpSpPr>
        <p:grpSpPr>
          <a:xfrm>
            <a:off x="133814" y="620688"/>
            <a:ext cx="11841500" cy="4599238"/>
            <a:chOff x="133814" y="620688"/>
            <a:chExt cx="11841500" cy="4599238"/>
          </a:xfrm>
        </p:grpSpPr>
        <p:grpSp>
          <p:nvGrpSpPr>
            <p:cNvPr id="20" name="组合 19">
              <a:extLst>
                <a:ext uri="{FF2B5EF4-FFF2-40B4-BE49-F238E27FC236}">
                  <a16:creationId xmlns:a16="http://schemas.microsoft.com/office/drawing/2014/main" id="{6C0ECA97-75F9-4BF7-85BA-1D62A96272E4}"/>
                </a:ext>
              </a:extLst>
            </p:cNvPr>
            <p:cNvGrpSpPr/>
            <p:nvPr/>
          </p:nvGrpSpPr>
          <p:grpSpPr>
            <a:xfrm>
              <a:off x="216685" y="620688"/>
              <a:ext cx="11758629" cy="3712665"/>
              <a:chOff x="197192" y="1588543"/>
              <a:chExt cx="11758629" cy="3712665"/>
            </a:xfrm>
          </p:grpSpPr>
          <p:grpSp>
            <p:nvGrpSpPr>
              <p:cNvPr id="18" name="组合 17">
                <a:extLst>
                  <a:ext uri="{FF2B5EF4-FFF2-40B4-BE49-F238E27FC236}">
                    <a16:creationId xmlns:a16="http://schemas.microsoft.com/office/drawing/2014/main" id="{908779C6-8116-4300-83F8-409ECB97FC22}"/>
                  </a:ext>
                </a:extLst>
              </p:cNvPr>
              <p:cNvGrpSpPr/>
              <p:nvPr/>
            </p:nvGrpSpPr>
            <p:grpSpPr>
              <a:xfrm>
                <a:off x="197192" y="1588543"/>
                <a:ext cx="11758629" cy="3712665"/>
                <a:chOff x="191344" y="2308303"/>
                <a:chExt cx="11758629" cy="3712665"/>
              </a:xfrm>
            </p:grpSpPr>
            <p:pic>
              <p:nvPicPr>
                <p:cNvPr id="9" name="图片 8">
                  <a:extLst>
                    <a:ext uri="{FF2B5EF4-FFF2-40B4-BE49-F238E27FC236}">
                      <a16:creationId xmlns:a16="http://schemas.microsoft.com/office/drawing/2014/main" id="{607FDDC2-442B-4BEE-B913-780312179EA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91344" y="3140968"/>
                  <a:ext cx="11348492" cy="2880000"/>
                </a:xfrm>
                <a:prstGeom prst="rect">
                  <a:avLst/>
                </a:prstGeom>
                <a:ln>
                  <a:noFill/>
                </a:ln>
              </p:spPr>
            </p:pic>
            <p:cxnSp>
              <p:nvCxnSpPr>
                <p:cNvPr id="11" name="直接箭头连接符 10">
                  <a:extLst>
                    <a:ext uri="{FF2B5EF4-FFF2-40B4-BE49-F238E27FC236}">
                      <a16:creationId xmlns:a16="http://schemas.microsoft.com/office/drawing/2014/main" id="{DBA67C01-CB5A-494A-8032-9C33CD831575}"/>
                    </a:ext>
                  </a:extLst>
                </p:cNvPr>
                <p:cNvCxnSpPr/>
                <p:nvPr/>
              </p:nvCxnSpPr>
              <p:spPr>
                <a:xfrm flipV="1">
                  <a:off x="6096000" y="4797152"/>
                  <a:ext cx="288032" cy="288032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13" name="图片 12">
                  <a:extLst>
                    <a:ext uri="{FF2B5EF4-FFF2-40B4-BE49-F238E27FC236}">
                      <a16:creationId xmlns:a16="http://schemas.microsoft.com/office/drawing/2014/main" id="{4E2E2C53-A44A-4884-95CB-3BB46FA2DFF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215" t="11755" r="3659" b="72635"/>
                <a:stretch/>
              </p:blipFill>
              <p:spPr>
                <a:xfrm>
                  <a:off x="6010507" y="4493942"/>
                  <a:ext cx="1315845" cy="267630"/>
                </a:xfrm>
                <a:prstGeom prst="rect">
                  <a:avLst/>
                </a:prstGeom>
              </p:spPr>
            </p:pic>
            <p:sp>
              <p:nvSpPr>
                <p:cNvPr id="14" name="文本框 13">
                  <a:extLst>
                    <a:ext uri="{FF2B5EF4-FFF2-40B4-BE49-F238E27FC236}">
                      <a16:creationId xmlns:a16="http://schemas.microsoft.com/office/drawing/2014/main" id="{8199686A-3EAA-4E1C-B3FF-7FCD85679FEE}"/>
                    </a:ext>
                  </a:extLst>
                </p:cNvPr>
                <p:cNvSpPr txBox="1"/>
                <p:nvPr/>
              </p:nvSpPr>
              <p:spPr>
                <a:xfrm>
                  <a:off x="5728608" y="3529861"/>
                  <a:ext cx="1672636" cy="861774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r>
                    <a:rPr lang="en-US" altLang="zh-CN" sz="1000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4</a:t>
                  </a:r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</a:t>
                  </a:r>
                  <a:r>
                    <a:rPr lang="en-US" altLang="zh-CN" sz="1000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4</a:t>
                  </a:r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</a:t>
                  </a:r>
                  <a:r>
                    <a:rPr lang="en-US" altLang="zh-CN" sz="1000" b="1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1</a:t>
                  </a:r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-e</a:t>
                  </a:r>
                </a:p>
                <a:p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ragment m/z:</a:t>
                  </a:r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539.2616</a:t>
                  </a:r>
                </a:p>
                <a:p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eak m/z:</a:t>
                  </a:r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539.2589</a:t>
                  </a:r>
                </a:p>
                <a:p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rror (ppm): </a:t>
                  </a:r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4.58</a:t>
                  </a:r>
                </a:p>
                <a:p>
                  <a:r>
                    <a:rPr lang="en-US" altLang="zh-CN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arge: </a:t>
                  </a:r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zh-CN" altLang="en-US" sz="105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文本框 14">
                  <a:extLst>
                    <a:ext uri="{FF2B5EF4-FFF2-40B4-BE49-F238E27FC236}">
                      <a16:creationId xmlns:a16="http://schemas.microsoft.com/office/drawing/2014/main" id="{E78BDD47-8100-4C17-A4C8-DDC3B7837232}"/>
                    </a:ext>
                  </a:extLst>
                </p:cNvPr>
                <p:cNvSpPr txBox="1"/>
                <p:nvPr/>
              </p:nvSpPr>
              <p:spPr>
                <a:xfrm>
                  <a:off x="5010032" y="2409411"/>
                  <a:ext cx="3512635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I (O-36:1)</a:t>
                  </a:r>
                  <a:endParaRPr lang="zh-CN" altLang="en-US" b="1" dirty="0"/>
                </a:p>
              </p:txBody>
            </p:sp>
            <p:pic>
              <p:nvPicPr>
                <p:cNvPr id="17" name="图片 16">
                  <a:extLst>
                    <a:ext uri="{FF2B5EF4-FFF2-40B4-BE49-F238E27FC236}">
                      <a16:creationId xmlns:a16="http://schemas.microsoft.com/office/drawing/2014/main" id="{8EC3D5A2-3D84-462A-AF11-122B67241F9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-128" b="78590"/>
                <a:stretch/>
              </p:blipFill>
              <p:spPr>
                <a:xfrm>
                  <a:off x="7518493" y="2308303"/>
                  <a:ext cx="4431480" cy="678735"/>
                </a:xfrm>
                <a:prstGeom prst="rect">
                  <a:avLst/>
                </a:prstGeom>
              </p:spPr>
            </p:pic>
          </p:grpSp>
          <p:pic>
            <p:nvPicPr>
              <p:cNvPr id="19" name="图片 18">
                <a:extLst>
                  <a:ext uri="{FF2B5EF4-FFF2-40B4-BE49-F238E27FC236}">
                    <a16:creationId xmlns:a16="http://schemas.microsoft.com/office/drawing/2014/main" id="{D977349C-120F-4E86-86BF-870EC8DD038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 rot="757586">
                <a:off x="10353606" y="1601898"/>
                <a:ext cx="115834" cy="286537"/>
              </a:xfrm>
              <a:prstGeom prst="rect">
                <a:avLst/>
              </a:prstGeom>
            </p:spPr>
          </p:pic>
        </p:grpSp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C213A67B-027F-4FD0-B881-84847E1F419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734670" y="4463851"/>
              <a:ext cx="4465786" cy="756075"/>
            </a:xfrm>
            <a:prstGeom prst="rect">
              <a:avLst/>
            </a:prstGeom>
          </p:spPr>
        </p:pic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FC808B33-F26C-453F-B7ED-70F1456FF197}"/>
                </a:ext>
              </a:extLst>
            </p:cNvPr>
            <p:cNvSpPr txBox="1"/>
            <p:nvPr/>
          </p:nvSpPr>
          <p:spPr>
            <a:xfrm>
              <a:off x="133814" y="4605453"/>
              <a:ext cx="50626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Corresponding IS: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15:0-18:1(d7) PI (NH4 Salt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5" name="图片 24">
            <a:extLst>
              <a:ext uri="{FF2B5EF4-FFF2-40B4-BE49-F238E27FC236}">
                <a16:creationId xmlns:a16="http://schemas.microsoft.com/office/drawing/2014/main" id="{EC79078E-FA85-4E6D-837B-14A47E86A5A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20811974">
            <a:off x="8295255" y="4566703"/>
            <a:ext cx="115834" cy="2865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38440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D958067-F3B9-44A8-A312-BB67345BD550}"/>
              </a:ext>
            </a:extLst>
          </p:cNvPr>
          <p:cNvSpPr txBox="1"/>
          <p:nvPr/>
        </p:nvSpPr>
        <p:spPr>
          <a:xfrm>
            <a:off x="141980" y="5657671"/>
            <a:ext cx="1164265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C. MS/MS spectrum of a precursor at m/z 890.6437 (ID: 1.73_890.6437m/z, RT=1.73 min) in positive mode with adducts [M+H-H2O]</a:t>
            </a:r>
            <a:r>
              <a:rPr lang="en-US" altLang="zh-CN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MS/MS spectrum was generated from MS</a:t>
            </a:r>
            <a:r>
              <a:rPr lang="en-US" altLang="zh-CN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w data using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genesi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QI software. Fragments indicate that it’s C24 (OH) Sulfatide. The lightning shape represents the site of  bond breakage.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7D122F4-B2D9-4FA7-8487-03DA3FBE55B0}"/>
              </a:ext>
            </a:extLst>
          </p:cNvPr>
          <p:cNvSpPr txBox="1"/>
          <p:nvPr/>
        </p:nvSpPr>
        <p:spPr>
          <a:xfrm>
            <a:off x="122663" y="267630"/>
            <a:ext cx="7136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5ABD70BE-0AF9-4EE3-8682-946739AADE21}"/>
              </a:ext>
            </a:extLst>
          </p:cNvPr>
          <p:cNvGrpSpPr/>
          <p:nvPr/>
        </p:nvGrpSpPr>
        <p:grpSpPr>
          <a:xfrm>
            <a:off x="174658" y="476672"/>
            <a:ext cx="11573193" cy="4743817"/>
            <a:chOff x="174658" y="476672"/>
            <a:chExt cx="11573193" cy="4743817"/>
          </a:xfrm>
        </p:grpSpPr>
        <p:grpSp>
          <p:nvGrpSpPr>
            <p:cNvPr id="20" name="组合 19">
              <a:extLst>
                <a:ext uri="{FF2B5EF4-FFF2-40B4-BE49-F238E27FC236}">
                  <a16:creationId xmlns:a16="http://schemas.microsoft.com/office/drawing/2014/main" id="{DB7539CF-B813-4EDA-BEAD-97FE26CEB97F}"/>
                </a:ext>
              </a:extLst>
            </p:cNvPr>
            <p:cNvGrpSpPr/>
            <p:nvPr/>
          </p:nvGrpSpPr>
          <p:grpSpPr>
            <a:xfrm>
              <a:off x="174658" y="476672"/>
              <a:ext cx="11573193" cy="3862163"/>
              <a:chOff x="191344" y="2158805"/>
              <a:chExt cx="11573193" cy="3862163"/>
            </a:xfrm>
          </p:grpSpPr>
          <p:pic>
            <p:nvPicPr>
              <p:cNvPr id="12" name="图片 11">
                <a:extLst>
                  <a:ext uri="{FF2B5EF4-FFF2-40B4-BE49-F238E27FC236}">
                    <a16:creationId xmlns:a16="http://schemas.microsoft.com/office/drawing/2014/main" id="{7FB2D5B7-2DB6-4C21-AC8F-17E7BE7A4D8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91344" y="3140968"/>
                <a:ext cx="11348495" cy="2880000"/>
              </a:xfrm>
              <a:prstGeom prst="rect">
                <a:avLst/>
              </a:prstGeom>
            </p:spPr>
          </p:pic>
          <p:cxnSp>
            <p:nvCxnSpPr>
              <p:cNvPr id="10" name="直接箭头连接符 9">
                <a:extLst>
                  <a:ext uri="{FF2B5EF4-FFF2-40B4-BE49-F238E27FC236}">
                    <a16:creationId xmlns:a16="http://schemas.microsoft.com/office/drawing/2014/main" id="{A8BAED04-9973-4019-9168-3655064E31F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375920" y="4941168"/>
                <a:ext cx="288032" cy="262528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5" name="图片 14">
                <a:extLst>
                  <a:ext uri="{FF2B5EF4-FFF2-40B4-BE49-F238E27FC236}">
                    <a16:creationId xmlns:a16="http://schemas.microsoft.com/office/drawing/2014/main" id="{E3936C59-D3D3-45B8-BFB4-2AF83F1CA66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224" t="10875" r="6974" b="70321"/>
              <a:stretch/>
            </p:blipFill>
            <p:spPr>
              <a:xfrm>
                <a:off x="5163014" y="4594302"/>
                <a:ext cx="1260087" cy="345688"/>
              </a:xfrm>
              <a:prstGeom prst="rect">
                <a:avLst/>
              </a:prstGeom>
            </p:spPr>
          </p:pic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F62108C9-9F20-48A5-8673-7CD55B00DA5E}"/>
                  </a:ext>
                </a:extLst>
              </p:cNvPr>
              <p:cNvSpPr txBox="1"/>
              <p:nvPr/>
            </p:nvSpPr>
            <p:spPr>
              <a:xfrm>
                <a:off x="5405225" y="3541013"/>
                <a:ext cx="1672636" cy="1023357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10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4</a:t>
                </a:r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lang="en-US" altLang="zh-CN" sz="10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41</a:t>
                </a:r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O</a:t>
                </a:r>
                <a:r>
                  <a:rPr lang="en-US" altLang="zh-CN" sz="10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+H-H</a:t>
                </a:r>
                <a:r>
                  <a:rPr lang="en-US" altLang="zh-CN" sz="10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</a:t>
                </a:r>
              </a:p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ragment m/z:</a:t>
                </a:r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503.2547</a:t>
                </a:r>
              </a:p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eak m/z:</a:t>
                </a:r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503.2558</a:t>
                </a:r>
              </a:p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rror (ppm): </a:t>
                </a:r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20</a:t>
                </a:r>
              </a:p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harge: </a:t>
                </a:r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eutral change: </a:t>
                </a:r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H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F964385E-80C3-4C35-9F2A-EF2C0FC735EA}"/>
                  </a:ext>
                </a:extLst>
              </p:cNvPr>
              <p:cNvSpPr txBox="1"/>
              <p:nvPr/>
            </p:nvSpPr>
            <p:spPr>
              <a:xfrm>
                <a:off x="5004729" y="2445014"/>
                <a:ext cx="351263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24 (OH) Sulfatide</a:t>
                </a:r>
                <a:endParaRPr lang="zh-CN" altLang="en-US" b="1" dirty="0"/>
              </a:p>
            </p:txBody>
          </p:sp>
          <p:pic>
            <p:nvPicPr>
              <p:cNvPr id="19" name="图片 18">
                <a:extLst>
                  <a:ext uri="{FF2B5EF4-FFF2-40B4-BE49-F238E27FC236}">
                    <a16:creationId xmlns:a16="http://schemas.microsoft.com/office/drawing/2014/main" id="{3F457F2E-3A38-425F-899C-3E4D3A2B958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-396" b="73868"/>
              <a:stretch/>
            </p:blipFill>
            <p:spPr>
              <a:xfrm>
                <a:off x="7553461" y="2158805"/>
                <a:ext cx="4211076" cy="785118"/>
              </a:xfrm>
              <a:prstGeom prst="rect">
                <a:avLst/>
              </a:prstGeom>
            </p:spPr>
          </p:pic>
        </p:grp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EE932BB8-09CE-4D08-8585-D65808838CB2}"/>
                </a:ext>
              </a:extLst>
            </p:cNvPr>
            <p:cNvSpPr txBox="1"/>
            <p:nvPr/>
          </p:nvSpPr>
          <p:spPr>
            <a:xfrm>
              <a:off x="174658" y="4576693"/>
              <a:ext cx="50626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Corresponding IS: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15:0-18:1(d7) PI (NH4 Salt)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988E8A39-F61F-41CF-AD7B-35241794979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776371" y="4464414"/>
              <a:ext cx="4465786" cy="756075"/>
            </a:xfrm>
            <a:prstGeom prst="rect">
              <a:avLst/>
            </a:prstGeom>
          </p:spPr>
        </p:pic>
      </p:grpSp>
      <p:pic>
        <p:nvPicPr>
          <p:cNvPr id="25" name="图片 24">
            <a:extLst>
              <a:ext uri="{FF2B5EF4-FFF2-40B4-BE49-F238E27FC236}">
                <a16:creationId xmlns:a16="http://schemas.microsoft.com/office/drawing/2014/main" id="{DDB50D58-CDA0-4875-8DBD-2C00FE41151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12138802">
            <a:off x="10339645" y="879369"/>
            <a:ext cx="115834" cy="286537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2E7FDEF9-9D61-477A-8E06-87720B42170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20811974">
            <a:off x="8339859" y="4555552"/>
            <a:ext cx="115834" cy="2865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49685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966ED9B4-99AB-4749-A998-607593A87A73}"/>
              </a:ext>
            </a:extLst>
          </p:cNvPr>
          <p:cNvSpPr txBox="1"/>
          <p:nvPr/>
        </p:nvSpPr>
        <p:spPr>
          <a:xfrm>
            <a:off x="96681" y="5675402"/>
            <a:ext cx="1164265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D. MS/MS spectrum of a precursor at m/z 714.5371 (ID: 1.85_714.5371m/z, RT=1.85 min) in positive mode with adducts [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+N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]</a:t>
            </a:r>
            <a:r>
              <a:rPr lang="en-US" altLang="zh-CN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MS/MS spectrum was generated from MS</a:t>
            </a:r>
            <a:r>
              <a:rPr lang="en-US" altLang="zh-CN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w data using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genesi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QI software. Fragments indicate that it’s PE (O-33:0). The lightning shape represents the site of  bond breakage. 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65A91066-BF63-430A-852F-BD95BB6D8476}"/>
              </a:ext>
            </a:extLst>
          </p:cNvPr>
          <p:cNvGrpSpPr/>
          <p:nvPr/>
        </p:nvGrpSpPr>
        <p:grpSpPr>
          <a:xfrm>
            <a:off x="174658" y="548680"/>
            <a:ext cx="11368527" cy="4719675"/>
            <a:chOff x="174658" y="548680"/>
            <a:chExt cx="11368527" cy="4719675"/>
          </a:xfrm>
        </p:grpSpPr>
        <p:grpSp>
          <p:nvGrpSpPr>
            <p:cNvPr id="16" name="组合 15">
              <a:extLst>
                <a:ext uri="{FF2B5EF4-FFF2-40B4-BE49-F238E27FC236}">
                  <a16:creationId xmlns:a16="http://schemas.microsoft.com/office/drawing/2014/main" id="{46A25759-D5D8-4E1D-9EA7-09D80B16E0CA}"/>
                </a:ext>
              </a:extLst>
            </p:cNvPr>
            <p:cNvGrpSpPr/>
            <p:nvPr/>
          </p:nvGrpSpPr>
          <p:grpSpPr>
            <a:xfrm>
              <a:off x="191344" y="548680"/>
              <a:ext cx="11351841" cy="3784092"/>
              <a:chOff x="485507" y="1806498"/>
              <a:chExt cx="11351841" cy="3784092"/>
            </a:xfrm>
          </p:grpSpPr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4D9213F6-AD66-420F-8AB3-DA3C65CB741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85507" y="2710590"/>
                <a:ext cx="11348493" cy="2880000"/>
              </a:xfrm>
              <a:prstGeom prst="rect">
                <a:avLst/>
              </a:prstGeom>
            </p:spPr>
          </p:pic>
          <p:pic>
            <p:nvPicPr>
              <p:cNvPr id="9" name="图片 8">
                <a:extLst>
                  <a:ext uri="{FF2B5EF4-FFF2-40B4-BE49-F238E27FC236}">
                    <a16:creationId xmlns:a16="http://schemas.microsoft.com/office/drawing/2014/main" id="{47787645-0DFD-4141-8D4F-7944D029E4E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722" t="11482" r="8474" b="73960"/>
              <a:stretch/>
            </p:blipFill>
            <p:spPr>
              <a:xfrm>
                <a:off x="1639228" y="2419814"/>
                <a:ext cx="1260089" cy="267630"/>
              </a:xfrm>
              <a:prstGeom prst="rect">
                <a:avLst/>
              </a:prstGeom>
            </p:spPr>
          </p:pic>
          <p:cxnSp>
            <p:nvCxnSpPr>
              <p:cNvPr id="11" name="直接箭头连接符 10">
                <a:extLst>
                  <a:ext uri="{FF2B5EF4-FFF2-40B4-BE49-F238E27FC236}">
                    <a16:creationId xmlns:a16="http://schemas.microsoft.com/office/drawing/2014/main" id="{8990EBA0-3FEB-48A3-A924-FBE5F8BCADC9}"/>
                  </a:ext>
                </a:extLst>
              </p:cNvPr>
              <p:cNvCxnSpPr/>
              <p:nvPr/>
            </p:nvCxnSpPr>
            <p:spPr>
              <a:xfrm flipV="1">
                <a:off x="1672683" y="2587083"/>
                <a:ext cx="200722" cy="20072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A8406E68-84A2-42F1-BA91-5E2EC34C887D}"/>
                  </a:ext>
                </a:extLst>
              </p:cNvPr>
              <p:cNvSpPr txBox="1"/>
              <p:nvPr/>
            </p:nvSpPr>
            <p:spPr>
              <a:xfrm>
                <a:off x="2071010" y="2715823"/>
                <a:ext cx="1672636" cy="1023357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altLang="zh-CN" sz="10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lang="en-US" altLang="zh-CN" sz="10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+Na</a:t>
                </a:r>
              </a:p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ragment m/z:</a:t>
                </a:r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219.1719</a:t>
                </a:r>
              </a:p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eak m/z:</a:t>
                </a:r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219.1744</a:t>
                </a:r>
              </a:p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rror (ppm): </a:t>
                </a:r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1.21</a:t>
                </a:r>
              </a:p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harge: </a:t>
                </a:r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eutral change: -</a:t>
                </a:r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endParaRPr lang="zh-CN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98A3167C-BEB0-4675-B441-27AAC5A01B17}"/>
                  </a:ext>
                </a:extLst>
              </p:cNvPr>
              <p:cNvSpPr txBox="1"/>
              <p:nvPr/>
            </p:nvSpPr>
            <p:spPr>
              <a:xfrm>
                <a:off x="5526067" y="1926640"/>
                <a:ext cx="351263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 (O-33:0)</a:t>
                </a:r>
              </a:p>
            </p:txBody>
          </p:sp>
          <p:pic>
            <p:nvPicPr>
              <p:cNvPr id="15" name="图片 14">
                <a:extLst>
                  <a:ext uri="{FF2B5EF4-FFF2-40B4-BE49-F238E27FC236}">
                    <a16:creationId xmlns:a16="http://schemas.microsoft.com/office/drawing/2014/main" id="{B6D28373-E3AE-4970-8410-26115E64B45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12" b="70406"/>
              <a:stretch/>
            </p:blipFill>
            <p:spPr>
              <a:xfrm>
                <a:off x="7423366" y="1806498"/>
                <a:ext cx="4413982" cy="936699"/>
              </a:xfrm>
              <a:prstGeom prst="rect">
                <a:avLst/>
              </a:prstGeom>
            </p:spPr>
          </p:pic>
        </p:grp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B6D025AA-E65C-4306-A031-19AE20740E92}"/>
                </a:ext>
              </a:extLst>
            </p:cNvPr>
            <p:cNvSpPr txBox="1"/>
            <p:nvPr/>
          </p:nvSpPr>
          <p:spPr>
            <a:xfrm>
              <a:off x="174658" y="4576693"/>
              <a:ext cx="50626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Corresponding IS: 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15:0-18:1(d7) PE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42C039F0-B5E2-471A-94CE-EFCC4283B8C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663952" y="4226425"/>
              <a:ext cx="4649165" cy="1041930"/>
            </a:xfrm>
            <a:prstGeom prst="rect">
              <a:avLst/>
            </a:prstGeom>
          </p:spPr>
        </p:pic>
      </p:grpSp>
      <p:sp>
        <p:nvSpPr>
          <p:cNvPr id="19" name="文本框 18">
            <a:extLst>
              <a:ext uri="{FF2B5EF4-FFF2-40B4-BE49-F238E27FC236}">
                <a16:creationId xmlns:a16="http://schemas.microsoft.com/office/drawing/2014/main" id="{40B30656-A107-418C-A913-18C9DECCEC3B}"/>
              </a:ext>
            </a:extLst>
          </p:cNvPr>
          <p:cNvSpPr txBox="1"/>
          <p:nvPr/>
        </p:nvSpPr>
        <p:spPr>
          <a:xfrm>
            <a:off x="122663" y="267630"/>
            <a:ext cx="7136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B39A6986-48D0-4154-83CC-E65F3C80EF4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8227073">
            <a:off x="10027413" y="990883"/>
            <a:ext cx="115834" cy="286537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E81A39CB-BA0F-452C-B453-E071BA29C8B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318494">
            <a:off x="8696702" y="4455197"/>
            <a:ext cx="115834" cy="286537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C06618ED-A173-40DC-8B8D-57CCC619ED3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10562167">
            <a:off x="8953179" y="4488649"/>
            <a:ext cx="115834" cy="2865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38049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02</TotalTime>
  <Words>534</Words>
  <Application>Microsoft Office PowerPoint</Application>
  <PresentationFormat>宽屏</PresentationFormat>
  <Paragraphs>55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赵倩倩(Qianqian Zhao)</dc:creator>
  <cp:lastModifiedBy>赵倩倩(Qianqian Zhao)</cp:lastModifiedBy>
  <cp:revision>42</cp:revision>
  <dcterms:created xsi:type="dcterms:W3CDTF">2019-12-13T07:39:50Z</dcterms:created>
  <dcterms:modified xsi:type="dcterms:W3CDTF">2020-05-18T08:21:56Z</dcterms:modified>
</cp:coreProperties>
</file>